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9F4D"/>
    <a:srgbClr val="F8B5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389"/>
    <p:restoredTop sz="80728"/>
  </p:normalViewPr>
  <p:slideViewPr>
    <p:cSldViewPr snapToGrid="0" snapToObjects="1">
      <p:cViewPr varScale="1">
        <p:scale>
          <a:sx n="76" d="100"/>
          <a:sy n="76" d="100"/>
        </p:scale>
        <p:origin x="1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3CF532-0012-6E4C-AE6E-658210682561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EC9674-6C6A-7F44-B719-E172203104AB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 The daily alteration of the nCD64 index, PCT, and temperature in infected patients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P1-P4, patient No.1 to No.4: Patients with respiratory tract infection. Infections were effectively controlled by antibiotic therapy, and discharged eventually; 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P5-P7, patient No.5 to No.7: Patients with blood infection. Antibiotic therapy was effective in P5, but ineffective in P6-P7. P5 was discharged, but P6 and P7 died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P8-P10, patient No.8 to No.10: patients with both blood and respiratory tract infection. Antibiotic therapy was effective in P8-P9, but ineffective in P10. P8-P9 were discharged, but P10 died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EC9674-6C6A-7F44-B719-E172203104AB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85EB1-D959-2546-9817-3A2BE7D9ED1A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A4647-FD80-1D44-A893-C19AE8486335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5356" y="317501"/>
            <a:ext cx="3600000" cy="498083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1790" y="317501"/>
            <a:ext cx="3600000" cy="511069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25" y="317501"/>
            <a:ext cx="3600000" cy="516105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13378" y="50217"/>
            <a:ext cx="568037" cy="248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139351" y="50217"/>
            <a:ext cx="568037" cy="248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8165324" y="50217"/>
            <a:ext cx="568037" cy="248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b="1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zh-CN" altLang="en-US" sz="1600" b="1" dirty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2065" y="5727065"/>
            <a:ext cx="12191365" cy="101473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200" b="1" dirty="0" smtClean="0">
                <a:effectLst/>
                <a:latin typeface="Arial Regular" panose="020B0604020202020204" charset="0"/>
                <a:cs typeface="Arial Regular" panose="020B0604020202020204" charset="0"/>
                <a:sym typeface="+mn-ea"/>
              </a:rPr>
              <a:t>Supplementary Figure 2 The daily alteration of the nCD64 index, PCT, and temperature in infected patients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Arial Regular" panose="020B0604020202020204" charset="0"/>
              <a:ea typeface="+mn-ea"/>
              <a:cs typeface="Arial Regular" panose="020B0604020202020204" charset="0"/>
            </a:endParaRPr>
          </a:p>
          <a:p>
            <a:r>
              <a:rPr lang="en-US" altLang="zh-CN" sz="1200" dirty="0" smtClean="0">
                <a:effectLst/>
                <a:latin typeface="Arial Regular" panose="020B0604020202020204" charset="0"/>
                <a:cs typeface="Arial Regular" panose="020B0604020202020204" charset="0"/>
                <a:sym typeface="+mn-ea"/>
              </a:rPr>
              <a:t>(A) P1-P4, patient No.1 to No.4: Patients with respiratory tract infection. Infections were effectively controlled by antibiotic therapy, and discharged eventually; 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Arial Regular" panose="020B0604020202020204" charset="0"/>
              <a:ea typeface="+mn-ea"/>
              <a:cs typeface="Arial Regular" panose="020B0604020202020204" charset="0"/>
            </a:endParaRPr>
          </a:p>
          <a:p>
            <a:r>
              <a:rPr lang="en-US" altLang="zh-CN" sz="1200" dirty="0" smtClean="0">
                <a:effectLst/>
                <a:latin typeface="Arial Regular" panose="020B0604020202020204" charset="0"/>
                <a:cs typeface="Arial Regular" panose="020B0604020202020204" charset="0"/>
                <a:sym typeface="+mn-ea"/>
              </a:rPr>
              <a:t>(B) P5-P7, patient No.5 to No.7: Patients with blood infection. Antibiotic therapy was effective in P5, but ineffective in P6-P7. P5 was discharged, but P6 and P7 died.</a:t>
            </a:r>
            <a:endParaRPr lang="zh-CN" altLang="zh-CN" sz="1200" kern="1200" dirty="0" smtClean="0">
              <a:solidFill>
                <a:schemeClr val="tx1"/>
              </a:solidFill>
              <a:effectLst/>
              <a:latin typeface="Arial Regular" panose="020B0604020202020204" charset="0"/>
              <a:ea typeface="+mn-ea"/>
              <a:cs typeface="Arial Regular" panose="020B0604020202020204" charset="0"/>
            </a:endParaRPr>
          </a:p>
          <a:p>
            <a:r>
              <a:rPr lang="en-US" altLang="zh-CN" sz="1200" dirty="0" smtClean="0">
                <a:effectLst/>
                <a:latin typeface="Arial Regular" panose="020B0604020202020204" charset="0"/>
                <a:cs typeface="Arial Regular" panose="020B0604020202020204" charset="0"/>
                <a:sym typeface="+mn-ea"/>
              </a:rPr>
              <a:t>(C) P8-P10, patient No.8 to No.10: patients with both blood and respiratory tract infection. Antibiotic therapy was effective in P8-P9, but ineffective in P10. P8-P9 were discharged, but P10 died.</a:t>
            </a:r>
            <a:endParaRPr lang="en-US" altLang="zh-CN" sz="1200" dirty="0" smtClean="0">
              <a:effectLst/>
              <a:latin typeface="Arial Regular" panose="020B0604020202020204" charset="0"/>
              <a:cs typeface="Arial Regular" panose="020B0604020202020204" charset="0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4</Words>
  <Application>WPS 文字</Application>
  <PresentationFormat>宽屏</PresentationFormat>
  <Paragraphs>1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7" baseType="lpstr">
      <vt:lpstr>Arial</vt:lpstr>
      <vt:lpstr>宋体</vt:lpstr>
      <vt:lpstr>Wingdings</vt:lpstr>
      <vt:lpstr>Arial</vt:lpstr>
      <vt:lpstr>Arial Regular</vt:lpstr>
      <vt:lpstr>微软雅黑</vt:lpstr>
      <vt:lpstr>汉仪旗黑</vt:lpstr>
      <vt:lpstr>宋体</vt:lpstr>
      <vt:lpstr>Arial Unicode MS</vt:lpstr>
      <vt:lpstr>DengXian Light</vt:lpstr>
      <vt:lpstr>汉仪中等线KW</vt:lpstr>
      <vt:lpstr>DengXian</vt:lpstr>
      <vt:lpstr>Calibri</vt:lpstr>
      <vt:lpstr>Helvetica Neue</vt:lpstr>
      <vt:lpstr>汉仪书宋二KW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739730610@qq.com</dc:creator>
  <cp:lastModifiedBy>Edee</cp:lastModifiedBy>
  <cp:revision>47</cp:revision>
  <cp:lastPrinted>2022-08-28T13:56:19Z</cp:lastPrinted>
  <dcterms:created xsi:type="dcterms:W3CDTF">2022-08-28T13:56:19Z</dcterms:created>
  <dcterms:modified xsi:type="dcterms:W3CDTF">2022-08-28T13:56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2CA3CC8863871B84F2D0863731A6BED</vt:lpwstr>
  </property>
  <property fmtid="{D5CDD505-2E9C-101B-9397-08002B2CF9AE}" pid="3" name="KSOProductBuildVer">
    <vt:lpwstr>2052-4.4.1.7360</vt:lpwstr>
  </property>
</Properties>
</file>